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45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396" y="102"/>
      </p:cViewPr>
      <p:guideLst>
        <p:guide orient="horz" pos="3045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9C4E66-5F2E-4047-8267-1300C195FE6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B1B584F-8E22-4CB6-A3E0-F5300D6950B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F7AAE6-4DC7-43F9-B552-3F0763DB3C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24AAA-C7B4-4EE5-B0E2-0D786AC8BA82}" type="datetimeFigureOut">
              <a:rPr lang="en-GB" smtClean="0"/>
              <a:t>16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693CBC-A932-421F-AFF7-C1E57D265F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C7C201-DEC2-43D1-A446-210E7A9B5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2680C-43E4-4D7E-8FDC-7E215E5685E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0650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BB859C-D736-4EE8-9ECE-AB0C193EFB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F83E6F-C7B4-4776-8B71-242C433604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556FFC-57CE-4F76-B681-5DCF43BEB9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24AAA-C7B4-4EE5-B0E2-0D786AC8BA82}" type="datetimeFigureOut">
              <a:rPr lang="en-GB" smtClean="0"/>
              <a:t>16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DFE8F5-FA81-424E-A4C2-0E7122526A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81E8D9-5702-4BFB-A349-842B95A4B8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2680C-43E4-4D7E-8FDC-7E215E5685E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83052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CA05CC4-8ADA-49C5-B1F6-B22C5E95BC4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0E4234-B33B-4AF1-9C4C-F0EEC18F76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CF70C1-4A9F-429A-98FB-BF78FA18DD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24AAA-C7B4-4EE5-B0E2-0D786AC8BA82}" type="datetimeFigureOut">
              <a:rPr lang="en-GB" smtClean="0"/>
              <a:t>16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DD9CA8-59D6-42EB-9003-97C6B4E9E5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D3AE5A-D70F-4098-A3E5-FEFC3B8288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2680C-43E4-4D7E-8FDC-7E215E5685E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4572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3759BE-9EA8-4D47-A8B4-78B6B46736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4F8E5E-0A43-4294-9EE6-2891BC66FC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9A53E9-8646-45E8-B32D-948B3D97CA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24AAA-C7B4-4EE5-B0E2-0D786AC8BA82}" type="datetimeFigureOut">
              <a:rPr lang="en-GB" smtClean="0"/>
              <a:t>16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2E2B65-1AAF-4278-BCC3-CAC8237758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B93DBE-1D42-4F57-BD21-A2D3ED9070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2680C-43E4-4D7E-8FDC-7E215E5685E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547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4BB04E-1964-4CD4-9A74-3E82187751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CB81AE-D81E-4A2B-A927-A744A9B4C4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989AD4-7A4C-4D56-8722-0E5ACB27DC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24AAA-C7B4-4EE5-B0E2-0D786AC8BA82}" type="datetimeFigureOut">
              <a:rPr lang="en-GB" smtClean="0"/>
              <a:t>16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03F9A9-12C2-450B-AE47-4243966128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3B2C50-C9C5-4609-B391-C539AAE9BE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2680C-43E4-4D7E-8FDC-7E215E5685E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5634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95C060-0411-4184-B5B0-F7A48CDCC0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396237-A0CC-426B-965B-33312871DB9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8F9DB9-F3EF-486C-868D-98A385BE07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C215B8-502E-489F-864E-DB26890601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24AAA-C7B4-4EE5-B0E2-0D786AC8BA82}" type="datetimeFigureOut">
              <a:rPr lang="en-GB" smtClean="0"/>
              <a:t>16/12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08921E-B208-4F98-BA59-EEC829B9F1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E33169-84A8-487F-BF97-EA92390A32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2680C-43E4-4D7E-8FDC-7E215E5685E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72393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87ECDD-4DEA-4F34-A914-BF49157D51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36F219-4B6F-49B5-BF7D-5B5CE6BE67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9DC49A1-E829-4A26-8027-ED32C757E5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A2258E7-997E-4E05-B7AA-48722E0DC21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6896799-5B2B-466B-B74E-B05F92071A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5677BA4-4872-44B6-98BA-94E6B1C273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24AAA-C7B4-4EE5-B0E2-0D786AC8BA82}" type="datetimeFigureOut">
              <a:rPr lang="en-GB" smtClean="0"/>
              <a:t>16/12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061BC30-B58C-43D6-B970-9BA48D781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3F50FDC-022B-4D3A-85A0-003DF5B619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2680C-43E4-4D7E-8FDC-7E215E5685E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49584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272D2C-F43A-41C0-86B9-1D261CBD40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E363E2E-9DAE-4A95-A6F5-AA9A86B923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24AAA-C7B4-4EE5-B0E2-0D786AC8BA82}" type="datetimeFigureOut">
              <a:rPr lang="en-GB" smtClean="0"/>
              <a:t>16/12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CBE748B-ED02-407E-8022-FCB55AB604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8FA8316-0170-45DF-862B-D8A7CEBFF5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2680C-43E4-4D7E-8FDC-7E215E5685E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82804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5631167-EAC8-4443-941B-2A9E187EB5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24AAA-C7B4-4EE5-B0E2-0D786AC8BA82}" type="datetimeFigureOut">
              <a:rPr lang="en-GB" smtClean="0"/>
              <a:t>16/12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A248045-80C2-469D-9E76-D248C8BEEB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E0F64A1-FE82-40ED-8F43-F23CECC075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2680C-43E4-4D7E-8FDC-7E215E5685E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7636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DEBA83-9DDB-4C3D-8F8B-3B6AF7D341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207857-1B60-428F-A968-1508BC86AD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3BE584-7D19-4875-AF42-E7134F028A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DD8E56-ACD2-4D12-914D-BD5FC1D172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24AAA-C7B4-4EE5-B0E2-0D786AC8BA82}" type="datetimeFigureOut">
              <a:rPr lang="en-GB" smtClean="0"/>
              <a:t>16/12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E12A53-066C-4FC9-B2B0-A753760F79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93FD3FD-1F90-437A-AFD6-7BDA058DA9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2680C-43E4-4D7E-8FDC-7E215E5685E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7684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23C50B-849D-411A-9106-E4DCC5EF9C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C1759CE-9907-4397-B164-ACAF4819886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3A1E78-0D14-4236-8723-F53A668CDD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42F26D-D973-4A6F-9604-2BF99EDED2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F24AAA-C7B4-4EE5-B0E2-0D786AC8BA82}" type="datetimeFigureOut">
              <a:rPr lang="en-GB" smtClean="0"/>
              <a:t>16/12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66F1A0-5252-40F8-A840-50796BE744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366E8E-8661-4649-BCA0-745CE80D06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2680C-43E4-4D7E-8FDC-7E215E5685E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79182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58A0924-2D04-4A35-A9EF-F35F31AFDA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16563F-255B-484E-8042-9F6EA7ACFE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2554FA-9BA4-492D-88A7-F9ADAF74CA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F24AAA-C7B4-4EE5-B0E2-0D786AC8BA82}" type="datetimeFigureOut">
              <a:rPr lang="en-GB" smtClean="0"/>
              <a:t>16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E5DD9D-F5AD-486A-928E-076F483061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404487-54D8-4C31-8B65-0FDF2FA5758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A2680C-43E4-4D7E-8FDC-7E215E5685EF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5147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3435EF4F-975C-4A88-8954-437CD4EB2D5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421363" y="5010960"/>
            <a:ext cx="9144000" cy="1655762"/>
          </a:xfrm>
        </p:spPr>
        <p:txBody>
          <a:bodyPr/>
          <a:lstStyle/>
          <a:p>
            <a:r>
              <a:rPr lang="en-GB" dirty="0"/>
              <a:t>Supplemental Information</a:t>
            </a:r>
          </a:p>
        </p:txBody>
      </p:sp>
      <p:sp>
        <p:nvSpPr>
          <p:cNvPr id="5" name="Title 4">
            <a:extLst>
              <a:ext uri="{FF2B5EF4-FFF2-40B4-BE49-F238E27FC236}">
                <a16:creationId xmlns:a16="http://schemas.microsoft.com/office/drawing/2014/main" id="{810A01BF-539B-4A11-B8C3-3BA3C402DE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421363" y="2092746"/>
            <a:ext cx="9144000" cy="2387600"/>
          </a:xfrm>
        </p:spPr>
        <p:txBody>
          <a:bodyPr>
            <a:noAutofit/>
          </a:bodyPr>
          <a:lstStyle/>
          <a:p>
            <a:r>
              <a:rPr lang="en-GB" sz="3200" b="1" dirty="0"/>
              <a:t>Optimizing the use of in vitro Transcribed SGK1-mRNA as a therapeutic tool to treat female infertility.</a:t>
            </a:r>
            <a:br>
              <a:rPr lang="en-GB" sz="3200" b="1" dirty="0"/>
            </a:br>
            <a:br>
              <a:rPr lang="en-GB" sz="3200" b="1" dirty="0"/>
            </a:br>
            <a:r>
              <a:rPr lang="en-GB" sz="2000" dirty="0"/>
              <a:t>Itishri Sahu1,2, Fabienne Engelmann3, Brian Weidensee1,2, </a:t>
            </a:r>
            <a:r>
              <a:rPr lang="en-GB" sz="2000" dirty="0" err="1"/>
              <a:t>Harivignesh</a:t>
            </a:r>
            <a:r>
              <a:rPr lang="en-GB" sz="2000" dirty="0"/>
              <a:t> Ganesan3,4, Sara Y. Brucker2, Yogesh Singh3,4 and Madhuri S. Salker3*</a:t>
            </a:r>
            <a:br>
              <a:rPr lang="en-GB" sz="2000" dirty="0"/>
            </a:br>
            <a:endParaRPr lang="en-GB" sz="2000" dirty="0"/>
          </a:p>
        </p:txBody>
      </p:sp>
    </p:spTree>
    <p:extLst>
      <p:ext uri="{BB962C8B-B14F-4D97-AF65-F5344CB8AC3E}">
        <p14:creationId xmlns:p14="http://schemas.microsoft.com/office/powerpoint/2010/main" val="39044178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4A5BC637-64A7-4856-839D-034D9C96665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976" t="48639" r="11407" b="31523"/>
          <a:stretch/>
        </p:blipFill>
        <p:spPr>
          <a:xfrm>
            <a:off x="6111791" y="4490495"/>
            <a:ext cx="3015579" cy="1176509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3DDC3E00-D564-4C7E-9DE3-ADBDD7DA20A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15" t="25089" r="49356" b="58055"/>
          <a:stretch/>
        </p:blipFill>
        <p:spPr>
          <a:xfrm>
            <a:off x="6192441" y="2679410"/>
            <a:ext cx="2955058" cy="986617"/>
          </a:xfrm>
          <a:prstGeom prst="rect">
            <a:avLst/>
          </a:prstGeom>
        </p:spPr>
      </p:pic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0B8E2D98-91EE-4B49-8A50-6A18D912184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706" r="29572"/>
          <a:stretch/>
        </p:blipFill>
        <p:spPr>
          <a:xfrm>
            <a:off x="1386214" y="4550198"/>
            <a:ext cx="4187093" cy="1866122"/>
          </a:xfr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16DD5FB-3EAC-4321-841B-C730E19475B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47" t="51723" r="26059" b="27248"/>
          <a:stretch/>
        </p:blipFill>
        <p:spPr>
          <a:xfrm>
            <a:off x="2715209" y="2528595"/>
            <a:ext cx="3041779" cy="1045029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1115280F-8BB9-4A3F-90DA-2CEC5CB09BF0}"/>
              </a:ext>
            </a:extLst>
          </p:cNvPr>
          <p:cNvSpPr/>
          <p:nvPr/>
        </p:nvSpPr>
        <p:spPr>
          <a:xfrm>
            <a:off x="3359020" y="3051109"/>
            <a:ext cx="625151" cy="2425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5CB41476-B37A-4517-AFB2-7B290FE243A0}"/>
              </a:ext>
            </a:extLst>
          </p:cNvPr>
          <p:cNvSpPr/>
          <p:nvPr/>
        </p:nvSpPr>
        <p:spPr>
          <a:xfrm>
            <a:off x="3464769" y="4689081"/>
            <a:ext cx="519402" cy="2425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EC9A583-DE47-4837-9419-0251F1A968FB}"/>
              </a:ext>
            </a:extLst>
          </p:cNvPr>
          <p:cNvSpPr txBox="1"/>
          <p:nvPr/>
        </p:nvSpPr>
        <p:spPr>
          <a:xfrm>
            <a:off x="3269080" y="2804888"/>
            <a:ext cx="8050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C WT SD KN</a:t>
            </a:r>
            <a:endParaRPr lang="en-GB" sz="10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4E6286D-C218-4359-80A9-A2753FDEE92A}"/>
              </a:ext>
            </a:extLst>
          </p:cNvPr>
          <p:cNvSpPr txBox="1"/>
          <p:nvPr/>
        </p:nvSpPr>
        <p:spPr>
          <a:xfrm>
            <a:off x="7462276" y="2769515"/>
            <a:ext cx="8050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C WT KN SD</a:t>
            </a:r>
            <a:endParaRPr lang="en-GB" sz="10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91FCAC5-8334-4E00-80A4-63E222441646}"/>
              </a:ext>
            </a:extLst>
          </p:cNvPr>
          <p:cNvSpPr txBox="1"/>
          <p:nvPr/>
        </p:nvSpPr>
        <p:spPr>
          <a:xfrm>
            <a:off x="3321955" y="4396726"/>
            <a:ext cx="8050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C WT SD KN</a:t>
            </a:r>
            <a:endParaRPr lang="en-GB" sz="10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9BF292E-6FB6-49CE-8E0F-301CE83EDD4F}"/>
              </a:ext>
            </a:extLst>
          </p:cNvPr>
          <p:cNvSpPr txBox="1"/>
          <p:nvPr/>
        </p:nvSpPr>
        <p:spPr>
          <a:xfrm>
            <a:off x="3990905" y="4407097"/>
            <a:ext cx="8050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C WT SD KN</a:t>
            </a:r>
            <a:endParaRPr lang="en-GB" sz="10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0C8AAF5-3664-4C9C-A00F-DF9DF5C58182}"/>
              </a:ext>
            </a:extLst>
          </p:cNvPr>
          <p:cNvSpPr txBox="1"/>
          <p:nvPr/>
        </p:nvSpPr>
        <p:spPr>
          <a:xfrm>
            <a:off x="4074109" y="2818364"/>
            <a:ext cx="8050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C WT SD KN</a:t>
            </a:r>
            <a:endParaRPr lang="en-GB" sz="10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09A08C0-6F52-462D-B4FB-0119456CEB47}"/>
              </a:ext>
            </a:extLst>
          </p:cNvPr>
          <p:cNvSpPr txBox="1"/>
          <p:nvPr/>
        </p:nvSpPr>
        <p:spPr>
          <a:xfrm>
            <a:off x="6866244" y="2255089"/>
            <a:ext cx="673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SGK1</a:t>
            </a:r>
            <a:endParaRPr lang="en-GB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3B9A8EE-73C9-42D0-96D7-0EF80FC917D7}"/>
              </a:ext>
            </a:extLst>
          </p:cNvPr>
          <p:cNvSpPr txBox="1"/>
          <p:nvPr/>
        </p:nvSpPr>
        <p:spPr>
          <a:xfrm>
            <a:off x="3899307" y="2214745"/>
            <a:ext cx="673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SGK1</a:t>
            </a:r>
            <a:endParaRPr lang="en-GB" dirty="0"/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F95A46E0-97B5-4FE2-906D-79C8D89B8FB9}"/>
              </a:ext>
            </a:extLst>
          </p:cNvPr>
          <p:cNvCxnSpPr/>
          <p:nvPr/>
        </p:nvCxnSpPr>
        <p:spPr>
          <a:xfrm>
            <a:off x="3163078" y="2641567"/>
            <a:ext cx="209938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B7FB4A73-456C-4CF8-9C95-C4C1E59C5A13}"/>
              </a:ext>
            </a:extLst>
          </p:cNvPr>
          <p:cNvCxnSpPr>
            <a:cxnSpLocks/>
          </p:cNvCxnSpPr>
          <p:nvPr/>
        </p:nvCxnSpPr>
        <p:spPr>
          <a:xfrm>
            <a:off x="6192441" y="2641567"/>
            <a:ext cx="2261081" cy="1056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BE3E3E0C-A403-424C-9D17-32AFF499C98D}"/>
              </a:ext>
            </a:extLst>
          </p:cNvPr>
          <p:cNvSpPr txBox="1"/>
          <p:nvPr/>
        </p:nvSpPr>
        <p:spPr>
          <a:xfrm>
            <a:off x="3899307" y="3959533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GAPDH</a:t>
            </a:r>
            <a:endParaRPr lang="en-GB" dirty="0"/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FFE33FE9-E5D6-446D-9CE4-1C347A168A91}"/>
              </a:ext>
            </a:extLst>
          </p:cNvPr>
          <p:cNvCxnSpPr/>
          <p:nvPr/>
        </p:nvCxnSpPr>
        <p:spPr>
          <a:xfrm>
            <a:off x="3163078" y="4386355"/>
            <a:ext cx="209938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ectangle 29">
            <a:extLst>
              <a:ext uri="{FF2B5EF4-FFF2-40B4-BE49-F238E27FC236}">
                <a16:creationId xmlns:a16="http://schemas.microsoft.com/office/drawing/2014/main" id="{1269499D-1D85-445F-ADD8-2F818A1531F4}"/>
              </a:ext>
            </a:extLst>
          </p:cNvPr>
          <p:cNvSpPr/>
          <p:nvPr/>
        </p:nvSpPr>
        <p:spPr>
          <a:xfrm>
            <a:off x="4187540" y="3051108"/>
            <a:ext cx="580915" cy="2425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AEE59C1D-112B-4A4B-93B0-591CE41E853F}"/>
              </a:ext>
            </a:extLst>
          </p:cNvPr>
          <p:cNvSpPr/>
          <p:nvPr/>
        </p:nvSpPr>
        <p:spPr>
          <a:xfrm>
            <a:off x="7549162" y="2967836"/>
            <a:ext cx="727479" cy="2425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669632B2-C3E7-446D-8C9C-2241CBE4AF5F}"/>
              </a:ext>
            </a:extLst>
          </p:cNvPr>
          <p:cNvSpPr/>
          <p:nvPr/>
        </p:nvSpPr>
        <p:spPr>
          <a:xfrm>
            <a:off x="4099118" y="4659795"/>
            <a:ext cx="519403" cy="2425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21755782-42A3-4382-93B4-7F96940ECC29}"/>
              </a:ext>
            </a:extLst>
          </p:cNvPr>
          <p:cNvSpPr/>
          <p:nvPr/>
        </p:nvSpPr>
        <p:spPr>
          <a:xfrm>
            <a:off x="7733717" y="4703302"/>
            <a:ext cx="552493" cy="2544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CEAC088-A61D-4B5E-9AAD-E2E9EA5B77DA}"/>
              </a:ext>
            </a:extLst>
          </p:cNvPr>
          <p:cNvSpPr txBox="1"/>
          <p:nvPr/>
        </p:nvSpPr>
        <p:spPr>
          <a:xfrm>
            <a:off x="7066417" y="3953724"/>
            <a:ext cx="946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GAPDH</a:t>
            </a:r>
            <a:endParaRPr lang="en-GB" dirty="0"/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6067BAD3-4EAC-4996-BFBA-299263381D13}"/>
              </a:ext>
            </a:extLst>
          </p:cNvPr>
          <p:cNvCxnSpPr>
            <a:cxnSpLocks/>
          </p:cNvCxnSpPr>
          <p:nvPr/>
        </p:nvCxnSpPr>
        <p:spPr>
          <a:xfrm>
            <a:off x="6436553" y="4408464"/>
            <a:ext cx="228699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feld 27">
            <a:extLst>
              <a:ext uri="{FF2B5EF4-FFF2-40B4-BE49-F238E27FC236}">
                <a16:creationId xmlns:a16="http://schemas.microsoft.com/office/drawing/2014/main" id="{B4E460ED-F236-45C5-BBE0-3B710D24BBE6}"/>
              </a:ext>
            </a:extLst>
          </p:cNvPr>
          <p:cNvSpPr txBox="1"/>
          <p:nvPr/>
        </p:nvSpPr>
        <p:spPr>
          <a:xfrm>
            <a:off x="10050143" y="2783170"/>
            <a:ext cx="10179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48 </a:t>
            </a:r>
            <a:r>
              <a:rPr lang="de-DE" dirty="0" err="1"/>
              <a:t>kDa</a:t>
            </a:r>
            <a:endParaRPr lang="de-DE" dirty="0"/>
          </a:p>
        </p:txBody>
      </p:sp>
      <p:cxnSp>
        <p:nvCxnSpPr>
          <p:cNvPr id="36" name="Gerade Verbindung mit Pfeil 35">
            <a:extLst>
              <a:ext uri="{FF2B5EF4-FFF2-40B4-BE49-F238E27FC236}">
                <a16:creationId xmlns:a16="http://schemas.microsoft.com/office/drawing/2014/main" id="{A11E0E9D-B139-4F0F-A4C9-3BE5E606634C}"/>
              </a:ext>
            </a:extLst>
          </p:cNvPr>
          <p:cNvCxnSpPr>
            <a:cxnSpLocks/>
          </p:cNvCxnSpPr>
          <p:nvPr/>
        </p:nvCxnSpPr>
        <p:spPr>
          <a:xfrm flipH="1">
            <a:off x="9517368" y="2975125"/>
            <a:ext cx="32887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feld 36">
            <a:extLst>
              <a:ext uri="{FF2B5EF4-FFF2-40B4-BE49-F238E27FC236}">
                <a16:creationId xmlns:a16="http://schemas.microsoft.com/office/drawing/2014/main" id="{E8BB311C-E2EC-4BDC-9A33-BC2E1A6CEC1B}"/>
              </a:ext>
            </a:extLst>
          </p:cNvPr>
          <p:cNvSpPr txBox="1"/>
          <p:nvPr/>
        </p:nvSpPr>
        <p:spPr>
          <a:xfrm>
            <a:off x="10238853" y="4689081"/>
            <a:ext cx="10179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37 </a:t>
            </a:r>
            <a:r>
              <a:rPr lang="de-DE" dirty="0" err="1"/>
              <a:t>kDa</a:t>
            </a:r>
            <a:endParaRPr lang="de-DE" dirty="0"/>
          </a:p>
        </p:txBody>
      </p:sp>
      <p:cxnSp>
        <p:nvCxnSpPr>
          <p:cNvPr id="38" name="Gerade Verbindung mit Pfeil 37">
            <a:extLst>
              <a:ext uri="{FF2B5EF4-FFF2-40B4-BE49-F238E27FC236}">
                <a16:creationId xmlns:a16="http://schemas.microsoft.com/office/drawing/2014/main" id="{DE6A84D9-66B6-4E67-BDDF-B11A7D5C837E}"/>
              </a:ext>
            </a:extLst>
          </p:cNvPr>
          <p:cNvCxnSpPr>
            <a:cxnSpLocks/>
          </p:cNvCxnSpPr>
          <p:nvPr/>
        </p:nvCxnSpPr>
        <p:spPr>
          <a:xfrm flipH="1">
            <a:off x="9706078" y="4881036"/>
            <a:ext cx="32887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feld 38">
            <a:extLst>
              <a:ext uri="{FF2B5EF4-FFF2-40B4-BE49-F238E27FC236}">
                <a16:creationId xmlns:a16="http://schemas.microsoft.com/office/drawing/2014/main" id="{95A5BE82-6FBE-4344-8060-7FDF72EC4F0C}"/>
              </a:ext>
            </a:extLst>
          </p:cNvPr>
          <p:cNvSpPr txBox="1"/>
          <p:nvPr/>
        </p:nvSpPr>
        <p:spPr>
          <a:xfrm>
            <a:off x="5460187" y="2924373"/>
            <a:ext cx="10179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48 </a:t>
            </a:r>
            <a:r>
              <a:rPr lang="de-DE" dirty="0" err="1"/>
              <a:t>kDa</a:t>
            </a:r>
            <a:endParaRPr lang="de-DE" dirty="0"/>
          </a:p>
        </p:txBody>
      </p:sp>
      <p:cxnSp>
        <p:nvCxnSpPr>
          <p:cNvPr id="40" name="Gerade Verbindung mit Pfeil 39">
            <a:extLst>
              <a:ext uri="{FF2B5EF4-FFF2-40B4-BE49-F238E27FC236}">
                <a16:creationId xmlns:a16="http://schemas.microsoft.com/office/drawing/2014/main" id="{6C47E77E-DABB-4278-88B5-D5B3402047E0}"/>
              </a:ext>
            </a:extLst>
          </p:cNvPr>
          <p:cNvCxnSpPr>
            <a:cxnSpLocks/>
          </p:cNvCxnSpPr>
          <p:nvPr/>
        </p:nvCxnSpPr>
        <p:spPr>
          <a:xfrm flipH="1">
            <a:off x="4927412" y="3116328"/>
            <a:ext cx="32887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feld 40">
            <a:extLst>
              <a:ext uri="{FF2B5EF4-FFF2-40B4-BE49-F238E27FC236}">
                <a16:creationId xmlns:a16="http://schemas.microsoft.com/office/drawing/2014/main" id="{244102D4-3396-4F75-BBAD-C1792C86E05D}"/>
              </a:ext>
            </a:extLst>
          </p:cNvPr>
          <p:cNvSpPr txBox="1"/>
          <p:nvPr/>
        </p:nvSpPr>
        <p:spPr>
          <a:xfrm>
            <a:off x="5469463" y="4562346"/>
            <a:ext cx="10179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37 </a:t>
            </a:r>
            <a:r>
              <a:rPr lang="de-DE" dirty="0" err="1"/>
              <a:t>kDa</a:t>
            </a:r>
            <a:endParaRPr lang="de-DE" dirty="0"/>
          </a:p>
        </p:txBody>
      </p:sp>
      <p:cxnSp>
        <p:nvCxnSpPr>
          <p:cNvPr id="42" name="Gerade Verbindung mit Pfeil 41">
            <a:extLst>
              <a:ext uri="{FF2B5EF4-FFF2-40B4-BE49-F238E27FC236}">
                <a16:creationId xmlns:a16="http://schemas.microsoft.com/office/drawing/2014/main" id="{968B6086-E4B2-4C0F-96E4-E592DC8FFADB}"/>
              </a:ext>
            </a:extLst>
          </p:cNvPr>
          <p:cNvCxnSpPr>
            <a:cxnSpLocks/>
          </p:cNvCxnSpPr>
          <p:nvPr/>
        </p:nvCxnSpPr>
        <p:spPr>
          <a:xfrm flipH="1">
            <a:off x="5047022" y="4743150"/>
            <a:ext cx="32887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FF4BD33F-A3DD-4235-861C-449178E79303}"/>
              </a:ext>
            </a:extLst>
          </p:cNvPr>
          <p:cNvSpPr txBox="1"/>
          <p:nvPr/>
        </p:nvSpPr>
        <p:spPr>
          <a:xfrm>
            <a:off x="2898205" y="6040677"/>
            <a:ext cx="58869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S1: Original WBs of SGK1 and GAPDH used in Figure 3.</a:t>
            </a:r>
            <a:br>
              <a:rPr lang="en-GB" dirty="0"/>
            </a:br>
            <a:endParaRPr lang="en-GB" dirty="0"/>
          </a:p>
        </p:txBody>
      </p:sp>
      <p:sp>
        <p:nvSpPr>
          <p:cNvPr id="8" name="Title 7">
            <a:extLst>
              <a:ext uri="{FF2B5EF4-FFF2-40B4-BE49-F238E27FC236}">
                <a16:creationId xmlns:a16="http://schemas.microsoft.com/office/drawing/2014/main" id="{35138973-8FE4-4AC5-8B88-B3E5CCCEE1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95D4AC9-7448-46A8-8BBD-698A0ED42827}"/>
              </a:ext>
            </a:extLst>
          </p:cNvPr>
          <p:cNvSpPr txBox="1"/>
          <p:nvPr/>
        </p:nvSpPr>
        <p:spPr>
          <a:xfrm>
            <a:off x="6439520" y="2763152"/>
            <a:ext cx="8050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C WT KN SD</a:t>
            </a:r>
            <a:endParaRPr lang="en-GB" sz="1000" dirty="0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53BC8E27-C1E9-42B7-8103-9C503C6C92CC}"/>
              </a:ext>
            </a:extLst>
          </p:cNvPr>
          <p:cNvSpPr/>
          <p:nvPr/>
        </p:nvSpPr>
        <p:spPr>
          <a:xfrm>
            <a:off x="6534797" y="2986607"/>
            <a:ext cx="635039" cy="2425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9FFC1D48-1B06-4CE4-841D-29A0EE362C52}"/>
              </a:ext>
            </a:extLst>
          </p:cNvPr>
          <p:cNvSpPr/>
          <p:nvPr/>
        </p:nvSpPr>
        <p:spPr>
          <a:xfrm>
            <a:off x="6559273" y="4694558"/>
            <a:ext cx="726963" cy="2544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325866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Content Placeholder 9">
            <a:extLst>
              <a:ext uri="{FF2B5EF4-FFF2-40B4-BE49-F238E27FC236}">
                <a16:creationId xmlns:a16="http://schemas.microsoft.com/office/drawing/2014/main" id="{BE5A462C-1809-466D-8839-8E3E02BF2B9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85" t="23923" r="785" b="24237"/>
          <a:stretch/>
        </p:blipFill>
        <p:spPr>
          <a:xfrm>
            <a:off x="1843456" y="2459902"/>
            <a:ext cx="7494449" cy="3107085"/>
          </a:xfr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C78C3123-F1EE-40A2-A27E-59FB13C18799}"/>
              </a:ext>
            </a:extLst>
          </p:cNvPr>
          <p:cNvSpPr/>
          <p:nvPr/>
        </p:nvSpPr>
        <p:spPr>
          <a:xfrm>
            <a:off x="6161317" y="3589424"/>
            <a:ext cx="808650" cy="2425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0528449-5411-44E7-9789-99E1F97A39B4}"/>
              </a:ext>
            </a:extLst>
          </p:cNvPr>
          <p:cNvSpPr txBox="1"/>
          <p:nvPr/>
        </p:nvSpPr>
        <p:spPr>
          <a:xfrm>
            <a:off x="6161317" y="3172408"/>
            <a:ext cx="8050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C WT SD KN</a:t>
            </a:r>
            <a:endParaRPr lang="en-GB" sz="10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0121641-D984-4910-83D2-A08C178D8396}"/>
              </a:ext>
            </a:extLst>
          </p:cNvPr>
          <p:cNvSpPr txBox="1"/>
          <p:nvPr/>
        </p:nvSpPr>
        <p:spPr>
          <a:xfrm>
            <a:off x="7035543" y="3182779"/>
            <a:ext cx="8050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C WT SD KN</a:t>
            </a:r>
            <a:endParaRPr lang="en-GB" sz="10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2592023-D21D-44FC-B9BA-A0547C84975F}"/>
              </a:ext>
            </a:extLst>
          </p:cNvPr>
          <p:cNvSpPr txBox="1"/>
          <p:nvPr/>
        </p:nvSpPr>
        <p:spPr>
          <a:xfrm>
            <a:off x="6738669" y="2735215"/>
            <a:ext cx="679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ENaC</a:t>
            </a:r>
            <a:endParaRPr lang="en-GB" dirty="0"/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2956938E-2E55-423C-8848-674B713D2504}"/>
              </a:ext>
            </a:extLst>
          </p:cNvPr>
          <p:cNvCxnSpPr/>
          <p:nvPr/>
        </p:nvCxnSpPr>
        <p:spPr>
          <a:xfrm>
            <a:off x="6002440" y="3162037"/>
            <a:ext cx="209938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17">
            <a:extLst>
              <a:ext uri="{FF2B5EF4-FFF2-40B4-BE49-F238E27FC236}">
                <a16:creationId xmlns:a16="http://schemas.microsoft.com/office/drawing/2014/main" id="{5D4BA0DD-2717-46D7-8635-505D88C13716}"/>
              </a:ext>
            </a:extLst>
          </p:cNvPr>
          <p:cNvSpPr/>
          <p:nvPr/>
        </p:nvSpPr>
        <p:spPr>
          <a:xfrm>
            <a:off x="6988628" y="3609366"/>
            <a:ext cx="808650" cy="2425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ACBD0ADA-A9F7-4D56-9C4F-8149BFFA8421}"/>
              </a:ext>
            </a:extLst>
          </p:cNvPr>
          <p:cNvSpPr/>
          <p:nvPr/>
        </p:nvSpPr>
        <p:spPr>
          <a:xfrm>
            <a:off x="7806616" y="3611191"/>
            <a:ext cx="808650" cy="2425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42849AB-FB58-4324-9BA4-03544D3D66DD}"/>
              </a:ext>
            </a:extLst>
          </p:cNvPr>
          <p:cNvSpPr txBox="1"/>
          <p:nvPr/>
        </p:nvSpPr>
        <p:spPr>
          <a:xfrm>
            <a:off x="7749611" y="3194154"/>
            <a:ext cx="8050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C WT SD KN</a:t>
            </a:r>
            <a:endParaRPr lang="en-GB" sz="1000" dirty="0"/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4E5035B6-0152-4F55-9423-74CF3E2C86AA}"/>
              </a:ext>
            </a:extLst>
          </p:cNvPr>
          <p:cNvSpPr txBox="1"/>
          <p:nvPr/>
        </p:nvSpPr>
        <p:spPr>
          <a:xfrm>
            <a:off x="9687464" y="3479571"/>
            <a:ext cx="10179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75 </a:t>
            </a:r>
            <a:r>
              <a:rPr lang="de-DE" dirty="0" err="1"/>
              <a:t>kDa</a:t>
            </a:r>
            <a:endParaRPr lang="de-DE" dirty="0"/>
          </a:p>
        </p:txBody>
      </p:sp>
      <p:cxnSp>
        <p:nvCxnSpPr>
          <p:cNvPr id="5" name="Gerade Verbindung mit Pfeil 4">
            <a:extLst>
              <a:ext uri="{FF2B5EF4-FFF2-40B4-BE49-F238E27FC236}">
                <a16:creationId xmlns:a16="http://schemas.microsoft.com/office/drawing/2014/main" id="{25E5FA5B-615E-4CCC-84DF-C4147DE3D0B7}"/>
              </a:ext>
            </a:extLst>
          </p:cNvPr>
          <p:cNvCxnSpPr>
            <a:cxnSpLocks/>
          </p:cNvCxnSpPr>
          <p:nvPr/>
        </p:nvCxnSpPr>
        <p:spPr>
          <a:xfrm flipH="1">
            <a:off x="9154689" y="3671526"/>
            <a:ext cx="32887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6BB02B48-046C-4B9D-9DC7-7BA9FF13C633}"/>
              </a:ext>
            </a:extLst>
          </p:cNvPr>
          <p:cNvSpPr txBox="1"/>
          <p:nvPr/>
        </p:nvSpPr>
        <p:spPr>
          <a:xfrm>
            <a:off x="2898205" y="6040677"/>
            <a:ext cx="474880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S2: Original WBs of ENaC used in Figure 3.</a:t>
            </a:r>
            <a:br>
              <a:rPr lang="en-GB" dirty="0"/>
            </a:br>
            <a:endParaRPr lang="en-GB" dirty="0"/>
          </a:p>
        </p:txBody>
      </p:sp>
      <p:sp>
        <p:nvSpPr>
          <p:cNvPr id="6" name="Title 5">
            <a:extLst>
              <a:ext uri="{FF2B5EF4-FFF2-40B4-BE49-F238E27FC236}">
                <a16:creationId xmlns:a16="http://schemas.microsoft.com/office/drawing/2014/main" id="{2B3BB4F0-E1E2-4018-A72E-24453D3C47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35962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6</Words>
  <Application>Microsoft Office PowerPoint</Application>
  <PresentationFormat>Breitbild</PresentationFormat>
  <Paragraphs>23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Optimizing the use of in vitro Transcribed SGK1-mRNA as a therapeutic tool to treat female infertility.  Itishri Sahu1,2, Fabienne Engelmann3, Brian Weidensee1,2, Harivignesh Ganesan3,4, Sara Y. Brucker2, Yogesh Singh3,4 and Madhuri S. Salker3* 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riginal blots</dc:title>
  <dc:creator>Dr. Madhuri Salker</dc:creator>
  <cp:lastModifiedBy>Zhiqi Yang</cp:lastModifiedBy>
  <cp:revision>13</cp:revision>
  <dcterms:created xsi:type="dcterms:W3CDTF">2024-12-06T14:28:42Z</dcterms:created>
  <dcterms:modified xsi:type="dcterms:W3CDTF">2024-12-16T10:37:56Z</dcterms:modified>
</cp:coreProperties>
</file>